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10260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D2E80-7DE7-4DA4-B886-98D54F6859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9818D-1FDE-42EB-B795-30E784B704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54D9D-613D-4622-B90F-0D3B3D3E09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DFC01-433B-4A89-A593-A6C01BB36D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1B43B-41E9-4127-A3B6-A5721E16E8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47D73-71BA-474B-BAC9-B6D85FE61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3EE94-96C8-45A5-AA3A-DC8318886F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BFEF6-8DCE-4D4B-A319-3A57D1A683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410760"/>
            <a:ext cx="6480000" cy="79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8043E-52F7-44D3-8420-344C71575B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A1EE2-B020-4D94-9348-ACBCF98EE3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E6C71-B68B-42D7-92C1-E4DE145580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5B9D4-6D6D-4E85-A7BB-FCD679BAC0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9344160"/>
            <a:ext cx="227952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A1DD8A-E55F-4409-849C-2F069F1E75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14707" r="0" b="18184"/>
          <a:stretch/>
        </p:blipFill>
        <p:spPr>
          <a:xfrm>
            <a:off x="399960" y="787320"/>
            <a:ext cx="6324840" cy="6046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52600" y="6958800"/>
            <a:ext cx="6248160" cy="188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resentatio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4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︱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-DE comparison of endosperm protein profiles between maize mutant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wild typ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represent two independent biological replicates. About 600 μg proteins were loaded into the 11-cm linear pH 4-7 IPG strips for IEF. Secondary SDS-PAGE was run in 13.5% gels. Approximately 380±10 CBB-stained spots were detected. PDQUEST analysis indicated that 15 protein spots showed obvious differences in abundance between the two genotypes, with a consistent change in two biological replicate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4-10-20T02:57:57Z</dcterms:modified>
  <cp:revision>2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4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4.PPT</vt:lpwstr>
  </property>
  <property fmtid="{D5CDD505-2E9C-101B-9397-08002B2CF9AE}" pid="6" name="Version">
    <vt:r8>1</vt:r8>
  </property>
</Properties>
</file>